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5486330F-A710-4C62-A58C-9296A049E3F0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1944F052-E0CE-49DA-B541-33023A60AA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024A3A-7A04-468C-99EC-D541850BD8E1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A606C3-EDFE-4150-9099-670BB76922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B7B4E7-6E73-493C-9C02-D80B1CAB9BF2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4E72BB-0F14-47CC-9352-529BAFD33D0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B14055-6C17-43F8-B7D0-B2C9FDBF17C3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9DC8DA-6D0C-48A3-8571-94E6FAD7D95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A8D94D-9F9F-4D45-8F6A-C16872BCA042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60CC50-CE8C-43B0-9538-FD14B4059ED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2EB1E-08C4-4676-9E9D-C5D688C19967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800D24-79DC-4579-8B22-3F6B4FC7FD6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433BCB-4A29-44C6-AD7E-33029D9353C4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B3214C-3554-4C44-B48D-88617148C7F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3465DC-CB06-49BF-9F2D-E5E104797E22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A53538-BD23-41AE-8A18-A5C2A7733E7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C50EC0-1DE4-435E-9AB7-48256E4F9AF7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86E638-17BA-4F4B-9E58-C0DA9DC66CE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974ED7-A885-486D-BF8D-A8B42240C0E3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1399DE-509A-422F-80EA-CFC7B32EBB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46600A-7057-49B6-8325-7C186F9CAAB8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7FB469-2558-48DC-AF89-B7C21D8F3EF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4C089D-0D34-4808-946E-A21EFE4A3648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A0144E-4984-4141-8C99-BC84B92E4F3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5CB0011-1311-429D-A179-43C266A5941F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62078AD-02C9-49CB-A4D9-98E945B22FB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503" name="Group 167"/>
          <p:cNvGraphicFramePr>
            <a:graphicFrameLocks noGrp="1"/>
          </p:cNvGraphicFramePr>
          <p:nvPr/>
        </p:nvGraphicFramePr>
        <p:xfrm>
          <a:off x="914400" y="685800"/>
          <a:ext cx="7396164" cy="5056198"/>
        </p:xfrm>
        <a:graphic>
          <a:graphicData uri="http://schemas.openxmlformats.org/drawingml/2006/table">
            <a:tbl>
              <a:tblPr/>
              <a:tblGrid>
                <a:gridCol w="566893"/>
                <a:gridCol w="800098"/>
                <a:gridCol w="800098"/>
                <a:gridCol w="800098"/>
                <a:gridCol w="800098"/>
                <a:gridCol w="3628879"/>
              </a:tblGrid>
              <a:tr h="4270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nimal No.</a:t>
                      </a:r>
                      <a:endParaRPr kumimoji="0" 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ge (weeks)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athology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emarks</a:t>
                      </a:r>
                      <a:endParaRPr kumimoji="0" 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VP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DLP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18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9.1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1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2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Desmoplastic stroma (DLP)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917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10.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2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2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2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Focal hyperplasia (AP, VP, DLP)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899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11.1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2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Hyperplasia (AP), desmoplastic stroma (DLP)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955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11.1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xtensive desmoplasia (AP)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189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19.6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2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xfoliation (AP), desmoplasia (VP)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1126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20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02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20.1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21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22.1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176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2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78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2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4942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34.7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4799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36.6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ronounced inflammation (AP)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002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39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085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39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787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41.6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788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41.6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1961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1.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                            Abscess, no glandular tissue (VP)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609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4.7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 with vascular invasion (AP)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940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45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6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 with extensive invasion and desmoplastic reaction (AP)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118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62.3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55217" marR="55217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</TotalTime>
  <Words>182</Words>
  <Application>Microsoft Office PowerPoint</Application>
  <PresentationFormat>On-screen Show (4:3)</PresentationFormat>
  <Paragraphs>13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elty</dc:creator>
  <cp:lastModifiedBy>Helty</cp:lastModifiedBy>
  <cp:revision>13</cp:revision>
  <dcterms:created xsi:type="dcterms:W3CDTF">2012-12-10T06:50:37Z</dcterms:created>
  <dcterms:modified xsi:type="dcterms:W3CDTF">2013-03-15T13:27:38Z</dcterms:modified>
</cp:coreProperties>
</file>